
<file path=[Content_Types].xml><?xml version="1.0" encoding="utf-8"?>
<Types xmlns="http://schemas.openxmlformats.org/package/2006/content-types">
  <Default Extension="xml" ContentType="application/xml"/>
  <Default Extension="mp4" ContentType="video/mp4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 snapToObjects="1" showGuides="1">
      <p:cViewPr varScale="1">
        <p:scale>
          <a:sx n="124" d="100"/>
          <a:sy n="124" d="100"/>
        </p:scale>
        <p:origin x="1824" y="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96640-51CC-8D47-A5E3-8463CF6300C6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E16FD-9EB6-AB43-8255-90ECF82CE7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91822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96640-51CC-8D47-A5E3-8463CF6300C6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E16FD-9EB6-AB43-8255-90ECF82CE7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33321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96640-51CC-8D47-A5E3-8463CF6300C6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E16FD-9EB6-AB43-8255-90ECF82CE7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58562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96640-51CC-8D47-A5E3-8463CF6300C6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E16FD-9EB6-AB43-8255-90ECF82CE7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46605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96640-51CC-8D47-A5E3-8463CF6300C6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E16FD-9EB6-AB43-8255-90ECF82CE7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4932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96640-51CC-8D47-A5E3-8463CF6300C6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E16FD-9EB6-AB43-8255-90ECF82CE7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6033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96640-51CC-8D47-A5E3-8463CF6300C6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E16FD-9EB6-AB43-8255-90ECF82CE7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8093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96640-51CC-8D47-A5E3-8463CF6300C6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E16FD-9EB6-AB43-8255-90ECF82CE7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14805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96640-51CC-8D47-A5E3-8463CF6300C6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E16FD-9EB6-AB43-8255-90ECF82CE7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7276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96640-51CC-8D47-A5E3-8463CF6300C6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E16FD-9EB6-AB43-8255-90ECF82CE7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11815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96640-51CC-8D47-A5E3-8463CF6300C6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E16FD-9EB6-AB43-8255-90ECF82CE7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1288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D96640-51CC-8D47-A5E3-8463CF6300C6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FE16FD-9EB6-AB43-8255-90ECF82CE7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06572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4" Type="http://schemas.openxmlformats.org/officeDocument/2006/relationships/image" Target="../media/image1.png"/><Relationship Id="rId1" Type="http://schemas.microsoft.com/office/2007/relationships/media" Target="../media/media1.mp4"/><Relationship Id="rId2" Type="http://schemas.openxmlformats.org/officeDocument/2006/relationships/video" Target="../media/media1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pic>
        <p:nvPicPr>
          <p:cNvPr id="4" name="TEE 短軸 一尖弁">
            <a:hlinkClick r:id="" action="ppaction://media"/>
            <a:extLst>
              <a:ext uri="{FF2B5EF4-FFF2-40B4-BE49-F238E27FC236}">
                <a16:creationId xmlns="" xmlns:a16="http://schemas.microsoft.com/office/drawing/2014/main" id="{EB6F8BD6-DEB5-49EE-990E-736015B35249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/>
          <a:srcRect t="9517"/>
          <a:stretch/>
        </p:blipFill>
        <p:spPr>
          <a:xfrm>
            <a:off x="1371600" y="1250651"/>
            <a:ext cx="6437648" cy="4368309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522554" y="5891768"/>
            <a:ext cx="81125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/>
              <a:t>Unicuspid</a:t>
            </a:r>
            <a:r>
              <a:rPr lang="en-US" altLang="ja-JP" dirty="0"/>
              <a:t> </a:t>
            </a:r>
            <a:r>
              <a:rPr lang="en-US" altLang="ja-JP" dirty="0" smtClean="0"/>
              <a:t>valve with </a:t>
            </a:r>
            <a:r>
              <a:rPr lang="en-US" altLang="ja-JP" dirty="0" err="1" smtClean="0"/>
              <a:t>unicommisural</a:t>
            </a:r>
            <a:r>
              <a:rPr lang="en-US" altLang="ja-JP" dirty="0" smtClean="0"/>
              <a:t> valve.</a:t>
            </a:r>
            <a:r>
              <a:rPr lang="ja-JP" altLang="en-US" dirty="0"/>
              <a:t>　</a:t>
            </a:r>
            <a:endParaRPr lang="en-US" altLang="ja-JP" dirty="0" smtClean="0"/>
          </a:p>
          <a:p>
            <a:r>
              <a:rPr lang="en-US" altLang="ja-JP" dirty="0"/>
              <a:t>E</a:t>
            </a:r>
            <a:r>
              <a:rPr lang="en-US" altLang="ja-JP" dirty="0" smtClean="0"/>
              <a:t>ccentric </a:t>
            </a:r>
            <a:r>
              <a:rPr lang="en-US" altLang="ja-JP" dirty="0"/>
              <a:t>orifice with commissural zone at NCC-LCC and one aortic leaflet with raphe</a:t>
            </a:r>
            <a:r>
              <a:rPr lang="ja-JP" altLang="ja-JP" dirty="0" smtClean="0">
                <a:effectLst/>
              </a:rPr>
              <a:t> 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10142664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958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6</Words>
  <Application>Microsoft Macintosh PowerPoint</Application>
  <PresentationFormat>画面に合わせる (4:3)</PresentationFormat>
  <Paragraphs>2</Paragraphs>
  <Slides>1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Calibri</vt:lpstr>
      <vt:lpstr>ＭＳ Ｐゴシック</vt:lpstr>
      <vt:lpstr>Arial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5.003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SHIKAZU TANAKA</dc:creator>
  <cp:lastModifiedBy>toshikazu tanaka</cp:lastModifiedBy>
  <cp:revision>2</cp:revision>
  <dcterms:created xsi:type="dcterms:W3CDTF">2018-12-11T10:07:22Z</dcterms:created>
  <dcterms:modified xsi:type="dcterms:W3CDTF">2019-08-31T03:52:52Z</dcterms:modified>
</cp:coreProperties>
</file>